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30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106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903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299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462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545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288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321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46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232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686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199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310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AEDC7A0-63BE-4F09-810A-CBC83406BEBC}"/>
              </a:ext>
            </a:extLst>
          </p:cNvPr>
          <p:cNvSpPr txBox="1"/>
          <p:nvPr/>
        </p:nvSpPr>
        <p:spPr>
          <a:xfrm>
            <a:off x="0" y="1807679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sFigure6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ultivariate cox hazard proportional analysis overall survival of the CRC patient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e performed multivariate Cox regression analysis to compute a HR according to age ≥ 70, male sex, depth of invasion (pT4), the presence of LN metastasis, low hemoglobin, GPS 1-2, NLR (≥ 5), PLR (≥150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w transferrin by using method “enter”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09B40089-7FCD-46B9-9619-D056D3A9B2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18076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4865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71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11</cp:revision>
  <dcterms:created xsi:type="dcterms:W3CDTF">2020-05-05T12:02:23Z</dcterms:created>
  <dcterms:modified xsi:type="dcterms:W3CDTF">2020-09-27T10:42:54Z</dcterms:modified>
</cp:coreProperties>
</file>